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C227E4-B7C8-4D80-BDF6-CB8B78CE9A91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955E3D-BF62-4DC3-B70D-A49EFD7D2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9580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1B29B4-EB25-4EB9-BCA3-0189A6263D24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4602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8391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536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1989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7488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2689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4507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6332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3499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3497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6717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8271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405634-0B2C-4C37-BEE8-239498ABF8D3}" type="datetimeFigureOut">
              <a:rPr lang="fr-FR" smtClean="0"/>
              <a:t>23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8B58E-22A1-4F47-BEAB-46FFD2159C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528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2FE7136B-9837-A6C5-A8A1-2EA58853D0F7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428331" y="1375562"/>
          <a:ext cx="3588909" cy="40743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4" imgW="4471445" imgH="5077092" progId="Prism8.Document">
                  <p:embed/>
                </p:oleObj>
              </mc:Choice>
              <mc:Fallback>
                <p:oleObj name="Prism 8" r:id="rId4" imgW="4471445" imgH="5077092" progId="Prism8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2FE7136B-9837-A6C5-A8A1-2EA58853D0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28331" y="1375562"/>
                        <a:ext cx="3588909" cy="40743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FBF5DCA4-4023-5B5E-2DA6-B0DB122E1754}"/>
              </a:ext>
            </a:extLst>
          </p:cNvPr>
          <p:cNvSpPr txBox="1"/>
          <p:nvPr/>
        </p:nvSpPr>
        <p:spPr>
          <a:xfrm>
            <a:off x="466359" y="5349167"/>
            <a:ext cx="435160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dirty="0"/>
              <a:t>* </a:t>
            </a:r>
            <a:r>
              <a:rPr lang="fr-FR" sz="1200" dirty="0"/>
              <a:t>Group is significantly different from Healthy control</a:t>
            </a: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F0AE9DB0-9EFC-1F2C-C825-CC2D424FC2C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286568" y="1375562"/>
          <a:ext cx="3588909" cy="40743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6" imgW="4471445" imgH="5077092" progId="Prism8.Document">
                  <p:embed/>
                </p:oleObj>
              </mc:Choice>
              <mc:Fallback>
                <p:oleObj name="Prism 8" r:id="rId6" imgW="4471445" imgH="5077092" progId="Prism8.Document">
                  <p:embed/>
                  <p:pic>
                    <p:nvPicPr>
                      <p:cNvPr id="9" name="Objet 8">
                        <a:extLst>
                          <a:ext uri="{FF2B5EF4-FFF2-40B4-BE49-F238E27FC236}">
                            <a16:creationId xmlns:a16="http://schemas.microsoft.com/office/drawing/2014/main" id="{F0AE9DB0-9EFC-1F2C-C825-CC2D424FC2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286568" y="1375562"/>
                        <a:ext cx="3588909" cy="40743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E48BB3C3-F4A7-6C88-3C8B-46A9F000324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66359" y="1391844"/>
          <a:ext cx="3661529" cy="40743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8" r:id="rId8" imgW="4562919" imgH="5077092" progId="Prism8.Document">
                  <p:embed/>
                </p:oleObj>
              </mc:Choice>
              <mc:Fallback>
                <p:oleObj name="Prism 8" r:id="rId8" imgW="4562919" imgH="5077092" progId="Prism8.Document">
                  <p:embed/>
                  <p:pic>
                    <p:nvPicPr>
                      <p:cNvPr id="10" name="Objet 9">
                        <a:extLst>
                          <a:ext uri="{FF2B5EF4-FFF2-40B4-BE49-F238E27FC236}">
                            <a16:creationId xmlns:a16="http://schemas.microsoft.com/office/drawing/2014/main" id="{E48BB3C3-F4A7-6C88-3C8B-46A9F00032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66359" y="1391844"/>
                        <a:ext cx="3661529" cy="40743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ZoneTexte 10">
            <a:extLst>
              <a:ext uri="{FF2B5EF4-FFF2-40B4-BE49-F238E27FC236}">
                <a16:creationId xmlns:a16="http://schemas.microsoft.com/office/drawing/2014/main" id="{93AD0D58-7B13-07D7-F01B-79CB1D4FA71B}"/>
              </a:ext>
            </a:extLst>
          </p:cNvPr>
          <p:cNvSpPr txBox="1"/>
          <p:nvPr/>
        </p:nvSpPr>
        <p:spPr>
          <a:xfrm>
            <a:off x="29155" y="5941853"/>
            <a:ext cx="121336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. S1 Cytokine mRNA expression in colon. Box and whiskers were plotted using the Tukey method. Statistical significance was determined by Kruskal-Wallis with Dunn’s multiple comparison test. *P &lt; 0.05, **P &lt; 0.01, ***P &lt; 0.001, ****P &lt; 0.0001, n = 16 mice per group, points shown on graph represent outliers outside of range calculated with Tukey’s method.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7820460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3BC636DE-B843-4B75-B169-8D1A3389858B}"/>
              </a:ext>
            </a:extLst>
          </p:cNvPr>
          <p:cNvSpPr txBox="1"/>
          <p:nvPr/>
        </p:nvSpPr>
        <p:spPr>
          <a:xfrm>
            <a:off x="567979" y="3429000"/>
            <a:ext cx="5351016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/>
              <a:t>Fig S2. Expression of </a:t>
            </a:r>
            <a:r>
              <a:rPr lang="en-US" sz="1600" dirty="0" smtClean="0"/>
              <a:t>hCAP18. </a:t>
            </a:r>
            <a:r>
              <a:rPr lang="en-US" sz="1600" dirty="0"/>
              <a:t>A) induced by plasmid vectors Probi-H1:hCAP18 and Probi-H1:empty in HEK293 </a:t>
            </a:r>
            <a:r>
              <a:rPr lang="en-US" sz="1600" dirty="0" smtClean="0"/>
              <a:t>cells (zoomed picture) </a:t>
            </a:r>
            <a:r>
              <a:rPr lang="en-US" sz="1600" dirty="0"/>
              <a:t>and B) in LL-pSEC:hCAP18 bacterial </a:t>
            </a:r>
            <a:r>
              <a:rPr lang="en-US" sz="1600" dirty="0" smtClean="0"/>
              <a:t>culture (zoomed and cropped picture to focus on </a:t>
            </a:r>
            <a:r>
              <a:rPr lang="en-US" sz="1600" smtClean="0"/>
              <a:t>relevant samples). </a:t>
            </a:r>
            <a:endParaRPr lang="fr-FR" sz="1600" dirty="0"/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3545E857-0CB6-4A7F-8977-71C26355EA13}"/>
              </a:ext>
            </a:extLst>
          </p:cNvPr>
          <p:cNvGrpSpPr/>
          <p:nvPr/>
        </p:nvGrpSpPr>
        <p:grpSpPr>
          <a:xfrm>
            <a:off x="681101" y="1363813"/>
            <a:ext cx="4634455" cy="1924392"/>
            <a:chOff x="6428911" y="910274"/>
            <a:chExt cx="4634455" cy="1924392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99E64BA8-76FC-4D53-A12A-7FAA7C920F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2131" r="817"/>
            <a:stretch/>
          </p:blipFill>
          <p:spPr>
            <a:xfrm>
              <a:off x="6949734" y="1317550"/>
              <a:ext cx="2153853" cy="1517116"/>
            </a:xfrm>
            <a:prstGeom prst="rect">
              <a:avLst/>
            </a:prstGeom>
          </p:spPr>
        </p:pic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0240823F-0849-41D2-B9FA-3CF1D46C9D49}"/>
                </a:ext>
              </a:extLst>
            </p:cNvPr>
            <p:cNvSpPr txBox="1"/>
            <p:nvPr/>
          </p:nvSpPr>
          <p:spPr>
            <a:xfrm>
              <a:off x="6434370" y="2411382"/>
              <a:ext cx="55087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dirty="0"/>
                <a:t>15kDa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CF4F825C-F44E-4D4D-AE96-C5FC67AA44AF}"/>
                </a:ext>
              </a:extLst>
            </p:cNvPr>
            <p:cNvSpPr txBox="1"/>
            <p:nvPr/>
          </p:nvSpPr>
          <p:spPr>
            <a:xfrm>
              <a:off x="6434367" y="2259706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25kDa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857D9DE5-AA50-49CA-8165-AE35D3A97C6C}"/>
                </a:ext>
              </a:extLst>
            </p:cNvPr>
            <p:cNvSpPr txBox="1"/>
            <p:nvPr/>
          </p:nvSpPr>
          <p:spPr>
            <a:xfrm>
              <a:off x="6434370" y="2108030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35kDa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E3CCD121-8D47-43E3-904B-168C2ACA654C}"/>
                </a:ext>
              </a:extLst>
            </p:cNvPr>
            <p:cNvSpPr txBox="1"/>
            <p:nvPr/>
          </p:nvSpPr>
          <p:spPr>
            <a:xfrm>
              <a:off x="6428911" y="1968685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40kDa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493AAA05-5B83-4745-92FE-C0D7BB0E050E}"/>
                </a:ext>
              </a:extLst>
            </p:cNvPr>
            <p:cNvSpPr txBox="1"/>
            <p:nvPr/>
          </p:nvSpPr>
          <p:spPr>
            <a:xfrm>
              <a:off x="7178852" y="1010078"/>
              <a:ext cx="9925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/>
                <a:t>Probi-H1:hCAP18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46F3084D-8D65-4596-9E5E-6FEBABA8B324}"/>
                </a:ext>
              </a:extLst>
            </p:cNvPr>
            <p:cNvSpPr txBox="1"/>
            <p:nvPr/>
          </p:nvSpPr>
          <p:spPr>
            <a:xfrm>
              <a:off x="8231855" y="1010078"/>
              <a:ext cx="9316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/>
                <a:t>Probi-H1:empty</a:t>
              </a:r>
            </a:p>
          </p:txBody>
        </p:sp>
        <p:cxnSp>
          <p:nvCxnSpPr>
            <p:cNvPr id="11" name="Connecteur droit 10">
              <a:extLst>
                <a:ext uri="{FF2B5EF4-FFF2-40B4-BE49-F238E27FC236}">
                  <a16:creationId xmlns:a16="http://schemas.microsoft.com/office/drawing/2014/main" id="{ABF9AA6F-14BE-4953-A3BA-8F5E6969E5FB}"/>
                </a:ext>
              </a:extLst>
            </p:cNvPr>
            <p:cNvCxnSpPr/>
            <p:nvPr/>
          </p:nvCxnSpPr>
          <p:spPr>
            <a:xfrm>
              <a:off x="7239276" y="1240910"/>
              <a:ext cx="89390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11">
              <a:extLst>
                <a:ext uri="{FF2B5EF4-FFF2-40B4-BE49-F238E27FC236}">
                  <a16:creationId xmlns:a16="http://schemas.microsoft.com/office/drawing/2014/main" id="{2A32463C-F5EA-46CA-99BF-1559216081BB}"/>
                </a:ext>
              </a:extLst>
            </p:cNvPr>
            <p:cNvCxnSpPr>
              <a:cxnSpLocks/>
            </p:cNvCxnSpPr>
            <p:nvPr/>
          </p:nvCxnSpPr>
          <p:spPr>
            <a:xfrm>
              <a:off x="8599009" y="1236772"/>
              <a:ext cx="389324" cy="41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7889BE27-6499-44F3-BAD3-331652E18805}"/>
                </a:ext>
              </a:extLst>
            </p:cNvPr>
            <p:cNvSpPr txBox="1"/>
            <p:nvPr/>
          </p:nvSpPr>
          <p:spPr>
            <a:xfrm>
              <a:off x="9435718" y="1005940"/>
              <a:ext cx="9412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/>
                <a:t>LL-pSEC:hCAP18</a:t>
              </a:r>
            </a:p>
          </p:txBody>
        </p:sp>
        <p:cxnSp>
          <p:nvCxnSpPr>
            <p:cNvPr id="14" name="Connecteur droit 13">
              <a:extLst>
                <a:ext uri="{FF2B5EF4-FFF2-40B4-BE49-F238E27FC236}">
                  <a16:creationId xmlns:a16="http://schemas.microsoft.com/office/drawing/2014/main" id="{D018F343-32FA-4B18-9215-0F96D50A9CBD}"/>
                </a:ext>
              </a:extLst>
            </p:cNvPr>
            <p:cNvCxnSpPr>
              <a:cxnSpLocks/>
            </p:cNvCxnSpPr>
            <p:nvPr/>
          </p:nvCxnSpPr>
          <p:spPr>
            <a:xfrm>
              <a:off x="9628496" y="1240910"/>
              <a:ext cx="37087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1B43C622-5F55-40FF-B025-B457FC118483}"/>
                </a:ext>
              </a:extLst>
            </p:cNvPr>
            <p:cNvSpPr txBox="1"/>
            <p:nvPr/>
          </p:nvSpPr>
          <p:spPr>
            <a:xfrm>
              <a:off x="6490875" y="952852"/>
              <a:ext cx="49974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dirty="0"/>
                <a:t>A)</a:t>
              </a:r>
              <a:endParaRPr lang="fr-FR" dirty="0"/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9B7E297C-9CC1-4FE6-8CFC-703D3297C354}"/>
                </a:ext>
              </a:extLst>
            </p:cNvPr>
            <p:cNvSpPr txBox="1"/>
            <p:nvPr/>
          </p:nvSpPr>
          <p:spPr>
            <a:xfrm>
              <a:off x="9163519" y="910274"/>
              <a:ext cx="54439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800" dirty="0"/>
                <a:t>B)</a:t>
              </a:r>
              <a:endParaRPr lang="fr-FR" dirty="0"/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0415BF8D-EE91-45D1-AECB-CD0C356538D5}"/>
                </a:ext>
              </a:extLst>
            </p:cNvPr>
            <p:cNvSpPr txBox="1"/>
            <p:nvPr/>
          </p:nvSpPr>
          <p:spPr>
            <a:xfrm>
              <a:off x="10512490" y="2416627"/>
              <a:ext cx="55087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50" dirty="0"/>
                <a:t>15kDa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051C82A3-77BE-4550-93AA-EBFCDA22A56D}"/>
                </a:ext>
              </a:extLst>
            </p:cNvPr>
            <p:cNvSpPr txBox="1"/>
            <p:nvPr/>
          </p:nvSpPr>
          <p:spPr>
            <a:xfrm>
              <a:off x="10512487" y="2293232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25kDa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F55443E4-E1B1-469F-A9F5-E184CBE7AAF5}"/>
                </a:ext>
              </a:extLst>
            </p:cNvPr>
            <p:cNvSpPr txBox="1"/>
            <p:nvPr/>
          </p:nvSpPr>
          <p:spPr>
            <a:xfrm>
              <a:off x="10512490" y="2150983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35kDa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213FFA1B-00F1-4014-B268-E2D842C652F1}"/>
                </a:ext>
              </a:extLst>
            </p:cNvPr>
            <p:cNvSpPr txBox="1"/>
            <p:nvPr/>
          </p:nvSpPr>
          <p:spPr>
            <a:xfrm>
              <a:off x="10507031" y="2021065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50" dirty="0"/>
                <a:t>40kDa</a:t>
              </a:r>
            </a:p>
          </p:txBody>
        </p:sp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191B52BD-4B41-4D79-BA0C-501C51EE37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-100000"/>
                      </a14:imgEffect>
                      <a14:imgEffect>
                        <a14:brightnessContrast bright="27000"/>
                      </a14:imgEffect>
                    </a14:imgLayer>
                  </a14:imgProps>
                </a:ext>
              </a:extLst>
            </a:blip>
            <a:srcRect l="1" r="7738"/>
            <a:stretch/>
          </p:blipFill>
          <p:spPr>
            <a:xfrm>
              <a:off x="9618494" y="1301219"/>
              <a:ext cx="888537" cy="151786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453979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Microsoft Office PowerPoint</Application>
  <PresentationFormat>Grand écran</PresentationFormat>
  <Paragraphs>17</Paragraphs>
  <Slides>2</Slides>
  <Notes>1</Notes>
  <HiddenSlides>1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ism 8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Marc Chatel</dc:creator>
  <cp:lastModifiedBy>Jean-Marc Chatel</cp:lastModifiedBy>
  <cp:revision>1</cp:revision>
  <dcterms:created xsi:type="dcterms:W3CDTF">2022-06-23T13:57:12Z</dcterms:created>
  <dcterms:modified xsi:type="dcterms:W3CDTF">2022-06-23T13:57:27Z</dcterms:modified>
</cp:coreProperties>
</file>